
<file path=[Content_Types].xml><?xml version="1.0" encoding="utf-8"?>
<Types xmlns="http://schemas.openxmlformats.org/package/2006/content-types">
  <Default Extension="jpeg" ContentType="image/jpeg"/>
  <Default Extension="jp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56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10"/>
    <p:restoredTop sz="94698"/>
  </p:normalViewPr>
  <p:slideViewPr>
    <p:cSldViewPr snapToGrid="0" snapToObjects="1">
      <p:cViewPr>
        <p:scale>
          <a:sx n="163" d="100"/>
          <a:sy n="163" d="100"/>
        </p:scale>
        <p:origin x="1328" y="-394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FBF85D-053A-1147-892B-7AFB506326F6}" type="datetimeFigureOut">
              <a:rPr kumimoji="1" lang="zh-CN" altLang="en-US" smtClean="0"/>
              <a:t>2019/9/16</a:t>
            </a:fld>
            <a:endParaRPr kumimoji="1"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C8D7DE-8B8B-2C49-8651-049E04FBA9CF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262516078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FBF85D-053A-1147-892B-7AFB506326F6}" type="datetimeFigureOut">
              <a:rPr kumimoji="1" lang="zh-CN" altLang="en-US" smtClean="0"/>
              <a:t>2019/9/16</a:t>
            </a:fld>
            <a:endParaRPr kumimoji="1"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C8D7DE-8B8B-2C49-8651-049E04FBA9CF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391014824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FBF85D-053A-1147-892B-7AFB506326F6}" type="datetimeFigureOut">
              <a:rPr kumimoji="1" lang="zh-CN" altLang="en-US" smtClean="0"/>
              <a:t>2019/9/16</a:t>
            </a:fld>
            <a:endParaRPr kumimoji="1"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C8D7DE-8B8B-2C49-8651-049E04FBA9CF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61557226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FBF85D-053A-1147-892B-7AFB506326F6}" type="datetimeFigureOut">
              <a:rPr kumimoji="1" lang="zh-CN" altLang="en-US" smtClean="0"/>
              <a:t>2019/9/16</a:t>
            </a:fld>
            <a:endParaRPr kumimoji="1"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C8D7DE-8B8B-2C49-8651-049E04FBA9CF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18738907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FBF85D-053A-1147-892B-7AFB506326F6}" type="datetimeFigureOut">
              <a:rPr kumimoji="1" lang="zh-CN" altLang="en-US" smtClean="0"/>
              <a:t>2019/9/16</a:t>
            </a:fld>
            <a:endParaRPr kumimoji="1"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C8D7DE-8B8B-2C49-8651-049E04FBA9CF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294070178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FBF85D-053A-1147-892B-7AFB506326F6}" type="datetimeFigureOut">
              <a:rPr kumimoji="1" lang="zh-CN" altLang="en-US" smtClean="0"/>
              <a:t>2019/9/16</a:t>
            </a:fld>
            <a:endParaRPr kumimoji="1"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C8D7DE-8B8B-2C49-8651-049E04FBA9CF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379859922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FBF85D-053A-1147-892B-7AFB506326F6}" type="datetimeFigureOut">
              <a:rPr kumimoji="1" lang="zh-CN" altLang="en-US" smtClean="0"/>
              <a:t>2019/9/16</a:t>
            </a:fld>
            <a:endParaRPr kumimoji="1"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C8D7DE-8B8B-2C49-8651-049E04FBA9CF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21806166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FBF85D-053A-1147-892B-7AFB506326F6}" type="datetimeFigureOut">
              <a:rPr kumimoji="1" lang="zh-CN" altLang="en-US" smtClean="0"/>
              <a:t>2019/9/16</a:t>
            </a:fld>
            <a:endParaRPr kumimoji="1"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C8D7DE-8B8B-2C49-8651-049E04FBA9CF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412373460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FBF85D-053A-1147-892B-7AFB506326F6}" type="datetimeFigureOut">
              <a:rPr kumimoji="1" lang="zh-CN" altLang="en-US" smtClean="0"/>
              <a:t>2019/9/16</a:t>
            </a:fld>
            <a:endParaRPr kumimoji="1"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C8D7DE-8B8B-2C49-8651-049E04FBA9CF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195538298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FBF85D-053A-1147-892B-7AFB506326F6}" type="datetimeFigureOut">
              <a:rPr kumimoji="1" lang="zh-CN" altLang="en-US" smtClean="0"/>
              <a:t>2019/9/16</a:t>
            </a:fld>
            <a:endParaRPr kumimoji="1"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C8D7DE-8B8B-2C49-8651-049E04FBA9CF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259544771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FBF85D-053A-1147-892B-7AFB506326F6}" type="datetimeFigureOut">
              <a:rPr kumimoji="1" lang="zh-CN" altLang="en-US" smtClean="0"/>
              <a:t>2019/9/16</a:t>
            </a:fld>
            <a:endParaRPr kumimoji="1"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C8D7DE-8B8B-2C49-8651-049E04FBA9CF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34450557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5FBF85D-053A-1147-892B-7AFB506326F6}" type="datetimeFigureOut">
              <a:rPr kumimoji="1" lang="zh-CN" altLang="en-US" smtClean="0"/>
              <a:t>2019/9/16</a:t>
            </a:fld>
            <a:endParaRPr kumimoji="1"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EC8D7DE-8B8B-2C49-8651-049E04FBA9CF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42007544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>
            <a:extLst>
              <a:ext uri="{FF2B5EF4-FFF2-40B4-BE49-F238E27FC236}">
                <a16:creationId xmlns:a16="http://schemas.microsoft.com/office/drawing/2014/main" id="{7BF5E8BD-6648-D34A-BA37-B3ED7576187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209357"/>
            <a:ext cx="6858000" cy="6993467"/>
          </a:xfrm>
          <a:prstGeom prst="rect">
            <a:avLst/>
          </a:prstGeom>
        </p:spPr>
      </p:pic>
      <p:sp>
        <p:nvSpPr>
          <p:cNvPr id="6" name="矩形 5">
            <a:extLst>
              <a:ext uri="{FF2B5EF4-FFF2-40B4-BE49-F238E27FC236}">
                <a16:creationId xmlns:a16="http://schemas.microsoft.com/office/drawing/2014/main" id="{C8361699-A160-A24F-BF0A-A96AEF4F6724}"/>
              </a:ext>
            </a:extLst>
          </p:cNvPr>
          <p:cNvSpPr/>
          <p:nvPr/>
        </p:nvSpPr>
        <p:spPr>
          <a:xfrm>
            <a:off x="0" y="7348754"/>
            <a:ext cx="6990348" cy="108504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marL="269875" marR="269875" algn="just">
              <a:lnSpc>
                <a:spcPts val="1300"/>
              </a:lnSpc>
              <a:spcBef>
                <a:spcPts val="600"/>
              </a:spcBef>
              <a:spcAft>
                <a:spcPts val="1200"/>
              </a:spcAft>
            </a:pPr>
            <a:r>
              <a:rPr lang="en-US" altLang="zh-CN" sz="1000" b="1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upplemental</a:t>
            </a:r>
            <a:r>
              <a:rPr lang="zh-CN" altLang="en-US" sz="1000" b="1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000" b="1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igure 1. Phylogenetic analysis of NtMADS-box proteins from tomato and cultivated tobacco. </a:t>
            </a:r>
            <a:r>
              <a:rPr lang="en-US" altLang="zh-CN" sz="1000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A total of 107 </a:t>
            </a:r>
            <a:r>
              <a:rPr lang="en-US" altLang="zh-CN" sz="1000" dirty="0" err="1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lMADS</a:t>
            </a:r>
            <a:r>
              <a:rPr lang="en-US" altLang="zh-CN" sz="1000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-box from tomato (</a:t>
            </a:r>
            <a:r>
              <a:rPr lang="en-US" altLang="zh-CN" sz="1000" i="1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olanum </a:t>
            </a:r>
            <a:r>
              <a:rPr lang="en-US" altLang="zh-CN" sz="1000" i="1" dirty="0" err="1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lycopersicum</a:t>
            </a:r>
            <a:r>
              <a:rPr lang="en-US" altLang="zh-CN" sz="1000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) and 168 NtMADS-box from cultivated tobacco were used to generate the unrooted neighbor-joining (NJ) tree with 1000 bootstrap replicates. The MADS proteins are classified into 5 subfamilies (marked as Mα, Mβ, Mγ, MIKC* and MIKC</a:t>
            </a:r>
            <a:r>
              <a:rPr lang="en-US" altLang="zh-CN" sz="1000" baseline="30000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r>
              <a:rPr lang="en-US" altLang="zh-CN" sz="1000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), and distinguished by different colors: NtMADS-box genes are labeled in solid circle, and </a:t>
            </a:r>
            <a:r>
              <a:rPr lang="en-US" altLang="zh-CN" sz="1000" dirty="0" err="1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lMADS</a:t>
            </a:r>
            <a:r>
              <a:rPr lang="en-US" altLang="zh-CN" sz="1000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-box genes are labeled in hollow circle.</a:t>
            </a:r>
            <a:endParaRPr lang="zh-CN" altLang="zh-CN" sz="1000" dirty="0">
              <a:solidFill>
                <a:srgbClr val="000000"/>
              </a:solidFill>
              <a:latin typeface="Palatino Linotype" panose="02040502050505030304" pitchFamily="18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9477227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5</TotalTime>
  <Words>93</Words>
  <Application>Microsoft Macintosh PowerPoint</Application>
  <PresentationFormat>A4 纸张(210x297 毫米)</PresentationFormat>
  <Paragraphs>1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Palatino Linotype</vt:lpstr>
      <vt:lpstr>Office 主题​​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wang zy</dc:creator>
  <cp:lastModifiedBy>wang zy</cp:lastModifiedBy>
  <cp:revision>1</cp:revision>
  <dcterms:created xsi:type="dcterms:W3CDTF">2019-09-16T12:41:25Z</dcterms:created>
  <dcterms:modified xsi:type="dcterms:W3CDTF">2019-09-16T12:46:45Z</dcterms:modified>
</cp:coreProperties>
</file>